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62" r:id="rId2"/>
  </p:sldIdLst>
  <p:sldSz cx="12960350" cy="21959888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68" autoAdjust="0"/>
    <p:restoredTop sz="94660"/>
  </p:normalViewPr>
  <p:slideViewPr>
    <p:cSldViewPr snapToGrid="0">
      <p:cViewPr>
        <p:scale>
          <a:sx n="48" d="100"/>
          <a:sy n="48" d="100"/>
        </p:scale>
        <p:origin x="-1542" y="240"/>
      </p:cViewPr>
      <p:guideLst>
        <p:guide orient="horz" pos="6916"/>
        <p:guide pos="40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0865300D-C0DB-4A38-BD44-A77EA31991B3}" type="datetimeFigureOut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674C055D-3DDC-4A69-8032-9333AC9DD4D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59915682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8CBEB62A-5263-4422-9935-2F8A43E720BE}" type="datetimeFigureOut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447925" y="1252538"/>
            <a:ext cx="1993900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34" tIns="48317" rIns="96634" bIns="48317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975" y="4823034"/>
            <a:ext cx="5511800" cy="3946118"/>
          </a:xfrm>
          <a:prstGeom prst="rect">
            <a:avLst/>
          </a:prstGeom>
        </p:spPr>
        <p:txBody>
          <a:bodyPr vert="horz" lIns="96634" tIns="48317" rIns="96634" bIns="48317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D3554FBB-5347-4C5F-BB9D-09F70482850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20570996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837965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67593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2513895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335186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4189826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5027791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5865756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6703721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2026" y="3593900"/>
            <a:ext cx="11016298" cy="7645294"/>
          </a:xfrm>
        </p:spPr>
        <p:txBody>
          <a:bodyPr anchor="b"/>
          <a:lstStyle>
            <a:lvl1pPr algn="ctr">
              <a:defRPr sz="850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20045" y="11534026"/>
            <a:ext cx="9720263" cy="5301888"/>
          </a:xfrm>
        </p:spPr>
        <p:txBody>
          <a:bodyPr/>
          <a:lstStyle>
            <a:lvl1pPr marL="0" indent="0" algn="ctr">
              <a:buNone/>
              <a:defRPr sz="3402"/>
            </a:lvl1pPr>
            <a:lvl2pPr marL="648004" indent="0" algn="ctr">
              <a:buNone/>
              <a:defRPr sz="2835"/>
            </a:lvl2pPr>
            <a:lvl3pPr marL="1296008" indent="0" algn="ctr">
              <a:buNone/>
              <a:defRPr sz="2551"/>
            </a:lvl3pPr>
            <a:lvl4pPr marL="1944013" indent="0" algn="ctr">
              <a:buNone/>
              <a:defRPr sz="2268"/>
            </a:lvl4pPr>
            <a:lvl5pPr marL="2592017" indent="0" algn="ctr">
              <a:buNone/>
              <a:defRPr sz="2268"/>
            </a:lvl5pPr>
            <a:lvl6pPr marL="3240020" indent="0" algn="ctr">
              <a:buNone/>
              <a:defRPr sz="2268"/>
            </a:lvl6pPr>
            <a:lvl7pPr marL="3888025" indent="0" algn="ctr">
              <a:buNone/>
              <a:defRPr sz="2268"/>
            </a:lvl7pPr>
            <a:lvl8pPr marL="4536030" indent="0" algn="ctr">
              <a:buNone/>
              <a:defRPr sz="2268"/>
            </a:lvl8pPr>
            <a:lvl9pPr marL="5184033" indent="0" algn="ctr">
              <a:buNone/>
              <a:defRPr sz="2268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3E5F-05D8-4883-BBA5-F544EA65A67D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0946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8F2E-E25A-4875-A211-19CDE50E7B66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63458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74753" y="1169161"/>
            <a:ext cx="2794575" cy="1860999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91025" y="1169161"/>
            <a:ext cx="8221722" cy="1860999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23612-7092-43E6-87EE-5F3D47EAF4D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775147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0705D-CDE0-4A8B-BD00-0C51EB3C5965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714432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4275" y="5474729"/>
            <a:ext cx="11178302" cy="9134702"/>
          </a:xfrm>
        </p:spPr>
        <p:txBody>
          <a:bodyPr anchor="b"/>
          <a:lstStyle>
            <a:lvl1pPr>
              <a:defRPr sz="850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4275" y="14695848"/>
            <a:ext cx="11178302" cy="4803724"/>
          </a:xfrm>
        </p:spPr>
        <p:txBody>
          <a:bodyPr/>
          <a:lstStyle>
            <a:lvl1pPr marL="0" indent="0">
              <a:buNone/>
              <a:defRPr sz="3402">
                <a:solidFill>
                  <a:schemeClr val="tx1"/>
                </a:solidFill>
              </a:defRPr>
            </a:lvl1pPr>
            <a:lvl2pPr marL="648004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2pPr>
            <a:lvl3pPr marL="1296008" indent="0">
              <a:buNone/>
              <a:defRPr sz="2551">
                <a:solidFill>
                  <a:schemeClr val="tx1">
                    <a:tint val="75000"/>
                  </a:schemeClr>
                </a:solidFill>
              </a:defRPr>
            </a:lvl3pPr>
            <a:lvl4pPr marL="1944013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4pPr>
            <a:lvl5pPr marL="2592017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5pPr>
            <a:lvl6pPr marL="324002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6pPr>
            <a:lvl7pPr marL="3888025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7pPr>
            <a:lvl8pPr marL="453603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8pPr>
            <a:lvl9pPr marL="5184033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4F3DD-5303-44B3-94EB-3881814DB7A2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111272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91024" y="5845805"/>
            <a:ext cx="5508149" cy="1393334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61179" y="5845805"/>
            <a:ext cx="5508149" cy="1393334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8C83-F889-49C6-8258-A889429BD78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472481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169166"/>
            <a:ext cx="11178302" cy="4244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2715" y="5383224"/>
            <a:ext cx="5482835" cy="2638235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04" indent="0">
              <a:buNone/>
              <a:defRPr sz="2835" b="1"/>
            </a:lvl2pPr>
            <a:lvl3pPr marL="1296008" indent="0">
              <a:buNone/>
              <a:defRPr sz="2551" b="1"/>
            </a:lvl3pPr>
            <a:lvl4pPr marL="1944013" indent="0">
              <a:buNone/>
              <a:defRPr sz="2268" b="1"/>
            </a:lvl4pPr>
            <a:lvl5pPr marL="2592017" indent="0">
              <a:buNone/>
              <a:defRPr sz="2268" b="1"/>
            </a:lvl5pPr>
            <a:lvl6pPr marL="3240020" indent="0">
              <a:buNone/>
              <a:defRPr sz="2268" b="1"/>
            </a:lvl6pPr>
            <a:lvl7pPr marL="3888025" indent="0">
              <a:buNone/>
              <a:defRPr sz="2268" b="1"/>
            </a:lvl7pPr>
            <a:lvl8pPr marL="4536030" indent="0">
              <a:buNone/>
              <a:defRPr sz="2268" b="1"/>
            </a:lvl8pPr>
            <a:lvl9pPr marL="5184033" indent="0">
              <a:buNone/>
              <a:defRPr sz="2268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2715" y="8021460"/>
            <a:ext cx="5482835" cy="1179835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61180" y="5383224"/>
            <a:ext cx="5509837" cy="2638235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04" indent="0">
              <a:buNone/>
              <a:defRPr sz="2835" b="1"/>
            </a:lvl2pPr>
            <a:lvl3pPr marL="1296008" indent="0">
              <a:buNone/>
              <a:defRPr sz="2551" b="1"/>
            </a:lvl3pPr>
            <a:lvl4pPr marL="1944013" indent="0">
              <a:buNone/>
              <a:defRPr sz="2268" b="1"/>
            </a:lvl4pPr>
            <a:lvl5pPr marL="2592017" indent="0">
              <a:buNone/>
              <a:defRPr sz="2268" b="1"/>
            </a:lvl5pPr>
            <a:lvl6pPr marL="3240020" indent="0">
              <a:buNone/>
              <a:defRPr sz="2268" b="1"/>
            </a:lvl6pPr>
            <a:lvl7pPr marL="3888025" indent="0">
              <a:buNone/>
              <a:defRPr sz="2268" b="1"/>
            </a:lvl7pPr>
            <a:lvl8pPr marL="4536030" indent="0">
              <a:buNone/>
              <a:defRPr sz="2268" b="1"/>
            </a:lvl8pPr>
            <a:lvl9pPr marL="5184033" indent="0">
              <a:buNone/>
              <a:defRPr sz="2268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61180" y="8021460"/>
            <a:ext cx="5509837" cy="1179835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85AAA-86E6-4820-B832-9D5BB2BD7504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244109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3C208-5E4C-41D1-9C78-730AEC10AC88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215179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92E73-36E3-4BA5-A847-F77E213AA44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514210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463993"/>
            <a:ext cx="4180050" cy="512397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509839" y="3161822"/>
            <a:ext cx="6561177" cy="15605754"/>
          </a:xfrm>
        </p:spPr>
        <p:txBody>
          <a:bodyPr/>
          <a:lstStyle>
            <a:lvl1pPr>
              <a:defRPr sz="4536"/>
            </a:lvl1pPr>
            <a:lvl2pPr>
              <a:defRPr sz="3968"/>
            </a:lvl2pPr>
            <a:lvl3pPr>
              <a:defRPr sz="3402"/>
            </a:lvl3pPr>
            <a:lvl4pPr>
              <a:defRPr sz="2835"/>
            </a:lvl4pPr>
            <a:lvl5pPr>
              <a:defRPr sz="2835"/>
            </a:lvl5pPr>
            <a:lvl6pPr>
              <a:defRPr sz="2835"/>
            </a:lvl6pPr>
            <a:lvl7pPr>
              <a:defRPr sz="2835"/>
            </a:lvl7pPr>
            <a:lvl8pPr>
              <a:defRPr sz="2835"/>
            </a:lvl8pPr>
            <a:lvl9pPr>
              <a:defRPr sz="2835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6587967"/>
            <a:ext cx="4180050" cy="12205023"/>
          </a:xfrm>
        </p:spPr>
        <p:txBody>
          <a:bodyPr/>
          <a:lstStyle>
            <a:lvl1pPr marL="0" indent="0">
              <a:buNone/>
              <a:defRPr sz="2268"/>
            </a:lvl1pPr>
            <a:lvl2pPr marL="648004" indent="0">
              <a:buNone/>
              <a:defRPr sz="1984"/>
            </a:lvl2pPr>
            <a:lvl3pPr marL="1296008" indent="0">
              <a:buNone/>
              <a:defRPr sz="1701"/>
            </a:lvl3pPr>
            <a:lvl4pPr marL="1944013" indent="0">
              <a:buNone/>
              <a:defRPr sz="1418"/>
            </a:lvl4pPr>
            <a:lvl5pPr marL="2592017" indent="0">
              <a:buNone/>
              <a:defRPr sz="1418"/>
            </a:lvl5pPr>
            <a:lvl6pPr marL="3240020" indent="0">
              <a:buNone/>
              <a:defRPr sz="1418"/>
            </a:lvl6pPr>
            <a:lvl7pPr marL="3888025" indent="0">
              <a:buNone/>
              <a:defRPr sz="1418"/>
            </a:lvl7pPr>
            <a:lvl8pPr marL="4536030" indent="0">
              <a:buNone/>
              <a:defRPr sz="1418"/>
            </a:lvl8pPr>
            <a:lvl9pPr marL="5184033" indent="0">
              <a:buNone/>
              <a:defRPr sz="141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ED3DE-4B30-48B5-95BB-DF6A3298C28C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91070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463993"/>
            <a:ext cx="4180050" cy="512397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509839" y="3161822"/>
            <a:ext cx="6561177" cy="15605754"/>
          </a:xfrm>
        </p:spPr>
        <p:txBody>
          <a:bodyPr anchor="t"/>
          <a:lstStyle>
            <a:lvl1pPr marL="0" indent="0">
              <a:buNone/>
              <a:defRPr sz="4536"/>
            </a:lvl1pPr>
            <a:lvl2pPr marL="648004" indent="0">
              <a:buNone/>
              <a:defRPr sz="3968"/>
            </a:lvl2pPr>
            <a:lvl3pPr marL="1296008" indent="0">
              <a:buNone/>
              <a:defRPr sz="3402"/>
            </a:lvl3pPr>
            <a:lvl4pPr marL="1944013" indent="0">
              <a:buNone/>
              <a:defRPr sz="2835"/>
            </a:lvl4pPr>
            <a:lvl5pPr marL="2592017" indent="0">
              <a:buNone/>
              <a:defRPr sz="2835"/>
            </a:lvl5pPr>
            <a:lvl6pPr marL="3240020" indent="0">
              <a:buNone/>
              <a:defRPr sz="2835"/>
            </a:lvl6pPr>
            <a:lvl7pPr marL="3888025" indent="0">
              <a:buNone/>
              <a:defRPr sz="2835"/>
            </a:lvl7pPr>
            <a:lvl8pPr marL="4536030" indent="0">
              <a:buNone/>
              <a:defRPr sz="2835"/>
            </a:lvl8pPr>
            <a:lvl9pPr marL="5184033" indent="0">
              <a:buNone/>
              <a:defRPr sz="2835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6587967"/>
            <a:ext cx="4180050" cy="12205023"/>
          </a:xfrm>
        </p:spPr>
        <p:txBody>
          <a:bodyPr/>
          <a:lstStyle>
            <a:lvl1pPr marL="0" indent="0">
              <a:buNone/>
              <a:defRPr sz="2268"/>
            </a:lvl1pPr>
            <a:lvl2pPr marL="648004" indent="0">
              <a:buNone/>
              <a:defRPr sz="1984"/>
            </a:lvl2pPr>
            <a:lvl3pPr marL="1296008" indent="0">
              <a:buNone/>
              <a:defRPr sz="1701"/>
            </a:lvl3pPr>
            <a:lvl4pPr marL="1944013" indent="0">
              <a:buNone/>
              <a:defRPr sz="1418"/>
            </a:lvl4pPr>
            <a:lvl5pPr marL="2592017" indent="0">
              <a:buNone/>
              <a:defRPr sz="1418"/>
            </a:lvl5pPr>
            <a:lvl6pPr marL="3240020" indent="0">
              <a:buNone/>
              <a:defRPr sz="1418"/>
            </a:lvl6pPr>
            <a:lvl7pPr marL="3888025" indent="0">
              <a:buNone/>
              <a:defRPr sz="1418"/>
            </a:lvl7pPr>
            <a:lvl8pPr marL="4536030" indent="0">
              <a:buNone/>
              <a:defRPr sz="1418"/>
            </a:lvl8pPr>
            <a:lvl9pPr marL="5184033" indent="0">
              <a:buNone/>
              <a:defRPr sz="141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E1A72-34A7-4777-9297-BECAC6DDF237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12150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91024" y="1169166"/>
            <a:ext cx="11178302" cy="4244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1024" y="5845805"/>
            <a:ext cx="11178302" cy="1393334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91026" y="20353569"/>
            <a:ext cx="2916079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E6F1D-3C5F-40DC-B246-DD4AB1E6FA63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93116" y="20353569"/>
            <a:ext cx="4374118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53249" y="20353569"/>
            <a:ext cx="2916079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10933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lvl1pPr algn="l" defTabSz="1296008" rtl="0" eaLnBrk="1" latinLnBrk="1" hangingPunct="1">
        <a:lnSpc>
          <a:spcPct val="90000"/>
        </a:lnSpc>
        <a:spcBef>
          <a:spcPct val="0"/>
        </a:spcBef>
        <a:buNone/>
        <a:defRPr sz="623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4003" indent="-324003" algn="l" defTabSz="1296008" rtl="0" eaLnBrk="1" latinLnBrk="1" hangingPunct="1">
        <a:lnSpc>
          <a:spcPct val="90000"/>
        </a:lnSpc>
        <a:spcBef>
          <a:spcPts val="1418"/>
        </a:spcBef>
        <a:buFont typeface="Arial" panose="020B0604020202020204" pitchFamily="34" charset="0"/>
        <a:buChar char="•"/>
        <a:defRPr sz="3968" kern="1200">
          <a:solidFill>
            <a:schemeClr val="tx1"/>
          </a:solidFill>
          <a:latin typeface="+mn-lt"/>
          <a:ea typeface="+mn-ea"/>
          <a:cs typeface="+mn-cs"/>
        </a:defRPr>
      </a:lvl1pPr>
      <a:lvl2pPr marL="972007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3402" kern="1200">
          <a:solidFill>
            <a:schemeClr val="tx1"/>
          </a:solidFill>
          <a:latin typeface="+mn-lt"/>
          <a:ea typeface="+mn-ea"/>
          <a:cs typeface="+mn-cs"/>
        </a:defRPr>
      </a:lvl2pPr>
      <a:lvl3pPr marL="1620010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268014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916020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564023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4212027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860032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508036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1pPr>
      <a:lvl2pPr marL="648004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2pPr>
      <a:lvl3pPr marL="1296008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3pPr>
      <a:lvl4pPr marL="1944013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592017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24002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3888025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53603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184033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그룹 18"/>
          <p:cNvGrpSpPr/>
          <p:nvPr/>
        </p:nvGrpSpPr>
        <p:grpSpPr>
          <a:xfrm>
            <a:off x="4149694" y="6513814"/>
            <a:ext cx="5249737" cy="2825938"/>
            <a:chOff x="4516055" y="6400000"/>
            <a:chExt cx="5249737" cy="2825938"/>
          </a:xfrm>
        </p:grpSpPr>
        <p:grpSp>
          <p:nvGrpSpPr>
            <p:cNvPr id="20" name="그룹 19"/>
            <p:cNvGrpSpPr/>
            <p:nvPr/>
          </p:nvGrpSpPr>
          <p:grpSpPr>
            <a:xfrm>
              <a:off x="4540345" y="8753280"/>
              <a:ext cx="5040905" cy="472658"/>
              <a:chOff x="3587192" y="10732440"/>
              <a:chExt cx="5740399" cy="472658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3587192" y="10886549"/>
                <a:ext cx="5740399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7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         0.5          1.0         1.5         2.0         2.5           3.0 (%)</a:t>
                </a:r>
                <a:endParaRPr lang="ko-KR" altLang="en-US" sz="147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23" name="그림 2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3739592" y="10732440"/>
                <a:ext cx="4698720" cy="199843"/>
              </a:xfrm>
              <a:prstGeom prst="rect">
                <a:avLst/>
              </a:prstGeom>
            </p:spPr>
          </p:pic>
        </p:grpSp>
        <p:pic>
          <p:nvPicPr>
            <p:cNvPr id="21" name="그림 2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516055" y="6400000"/>
              <a:ext cx="5249737" cy="2217700"/>
            </a:xfrm>
            <a:prstGeom prst="rect">
              <a:avLst/>
            </a:prstGeom>
          </p:spPr>
        </p:pic>
      </p:grpSp>
      <p:graphicFrame>
        <p:nvGraphicFramePr>
          <p:cNvPr id="11" name="표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014229249"/>
              </p:ext>
            </p:extLst>
          </p:nvPr>
        </p:nvGraphicFramePr>
        <p:xfrm>
          <a:off x="106141" y="1444287"/>
          <a:ext cx="12841662" cy="386700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60156">
                  <a:extLst>
                    <a:ext uri="{9D8B030D-6E8A-4147-A177-3AD203B41FA5}">
                      <a16:colId xmlns:a16="http://schemas.microsoft.com/office/drawing/2014/main" xmlns="" val="1409189042"/>
                    </a:ext>
                  </a:extLst>
                </a:gridCol>
                <a:gridCol w="116840">
                  <a:extLst>
                    <a:ext uri="{9D8B030D-6E8A-4147-A177-3AD203B41FA5}">
                      <a16:colId xmlns:a16="http://schemas.microsoft.com/office/drawing/2014/main" xmlns="" val="693893755"/>
                    </a:ext>
                  </a:extLst>
                </a:gridCol>
                <a:gridCol w="907288">
                  <a:extLst>
                    <a:ext uri="{9D8B030D-6E8A-4147-A177-3AD203B41FA5}">
                      <a16:colId xmlns:a16="http://schemas.microsoft.com/office/drawing/2014/main" xmlns="" val="9050658"/>
                    </a:ext>
                  </a:extLst>
                </a:gridCol>
                <a:gridCol w="1214120">
                  <a:extLst>
                    <a:ext uri="{9D8B030D-6E8A-4147-A177-3AD203B41FA5}">
                      <a16:colId xmlns:a16="http://schemas.microsoft.com/office/drawing/2014/main" xmlns="" val="4088979873"/>
                    </a:ext>
                  </a:extLst>
                </a:gridCol>
                <a:gridCol w="4620756">
                  <a:extLst>
                    <a:ext uri="{9D8B030D-6E8A-4147-A177-3AD203B41FA5}">
                      <a16:colId xmlns:a16="http://schemas.microsoft.com/office/drawing/2014/main" xmlns="" val="120783647"/>
                    </a:ext>
                  </a:extLst>
                </a:gridCol>
                <a:gridCol w="898359">
                  <a:extLst>
                    <a:ext uri="{9D8B030D-6E8A-4147-A177-3AD203B41FA5}">
                      <a16:colId xmlns:a16="http://schemas.microsoft.com/office/drawing/2014/main" xmlns="" val="3270725404"/>
                    </a:ext>
                  </a:extLst>
                </a:gridCol>
                <a:gridCol w="1267327">
                  <a:extLst>
                    <a:ext uri="{9D8B030D-6E8A-4147-A177-3AD203B41FA5}">
                      <a16:colId xmlns:a16="http://schemas.microsoft.com/office/drawing/2014/main" xmlns="" val="3683565691"/>
                    </a:ext>
                  </a:extLst>
                </a:gridCol>
                <a:gridCol w="850231">
                  <a:extLst>
                    <a:ext uri="{9D8B030D-6E8A-4147-A177-3AD203B41FA5}">
                      <a16:colId xmlns:a16="http://schemas.microsoft.com/office/drawing/2014/main" xmlns="" val="3525253308"/>
                    </a:ext>
                  </a:extLst>
                </a:gridCol>
                <a:gridCol w="906585">
                  <a:extLst>
                    <a:ext uri="{9D8B030D-6E8A-4147-A177-3AD203B41FA5}">
                      <a16:colId xmlns:a16="http://schemas.microsoft.com/office/drawing/2014/main" xmlns="" val="2749235395"/>
                    </a:ext>
                  </a:extLst>
                </a:gridCol>
              </a:tblGrid>
              <a:tr h="404646">
                <a:tc rowSpan="2"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2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.      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S/ME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es o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Physician diagnosis</a:t>
                      </a: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 Rate (%)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e (%)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-CI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 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06282246"/>
                  </a:ext>
                </a:extLst>
              </a:tr>
              <a:tr h="404646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78852647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acul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al.,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2011 [37]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15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8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7; 0.21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8944288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acul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37]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15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9; 0.12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53068010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acul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37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15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2; 0.04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6495113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ijhof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67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63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9; 0.14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80887130"/>
                  </a:ext>
                </a:extLst>
              </a:tr>
              <a:tr h="280087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o-yen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Mc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1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36]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899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2; 0.15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45126928"/>
                  </a:ext>
                </a:extLst>
              </a:tr>
              <a:tr h="280087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loyd 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al.,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1990 [25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00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3; 0.05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5417558"/>
                  </a:ext>
                </a:extLst>
              </a:tr>
              <a:tr h="369205">
                <a:tc gridSpan="2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effect model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11; 0.13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4201241"/>
                  </a:ext>
                </a:extLst>
              </a:tr>
              <a:tr h="256076">
                <a:tc gridSpan="3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s 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.0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05; 0.13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57745429"/>
                  </a:ext>
                </a:extLst>
              </a:tr>
              <a:tr h="556781"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500" i="1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ko-KR" sz="1500" baseline="30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97.5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0.2952</a:t>
                      </a:r>
                    </a:p>
                    <a:p>
                      <a:pPr marL="0" marR="0" lvl="0" indent="0" algn="l" defTabSz="1320759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lt;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.01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38004142"/>
                  </a:ext>
                </a:extLst>
              </a:tr>
            </a:tbl>
          </a:graphicData>
        </a:graphic>
      </p:graphicFrame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000210176"/>
              </p:ext>
            </p:extLst>
          </p:nvPr>
        </p:nvGraphicFramePr>
        <p:xfrm>
          <a:off x="106141" y="5794372"/>
          <a:ext cx="12834550" cy="359985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41868">
                  <a:extLst>
                    <a:ext uri="{9D8B030D-6E8A-4147-A177-3AD203B41FA5}">
                      <a16:colId xmlns:a16="http://schemas.microsoft.com/office/drawing/2014/main" xmlns="" val="1409189042"/>
                    </a:ext>
                  </a:extLst>
                </a:gridCol>
                <a:gridCol w="146304">
                  <a:extLst>
                    <a:ext uri="{9D8B030D-6E8A-4147-A177-3AD203B41FA5}">
                      <a16:colId xmlns:a16="http://schemas.microsoft.com/office/drawing/2014/main" xmlns="" val="1623739920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xmlns="" val="424758494"/>
                    </a:ext>
                  </a:extLst>
                </a:gridCol>
                <a:gridCol w="1298448">
                  <a:extLst>
                    <a:ext uri="{9D8B030D-6E8A-4147-A177-3AD203B41FA5}">
                      <a16:colId xmlns:a16="http://schemas.microsoft.com/office/drawing/2014/main" xmlns="" val="4088979873"/>
                    </a:ext>
                  </a:extLst>
                </a:gridCol>
                <a:gridCol w="4511028">
                  <a:extLst>
                    <a:ext uri="{9D8B030D-6E8A-4147-A177-3AD203B41FA5}">
                      <a16:colId xmlns:a16="http://schemas.microsoft.com/office/drawing/2014/main" xmlns="" val="120783647"/>
                    </a:ext>
                  </a:extLst>
                </a:gridCol>
                <a:gridCol w="898359">
                  <a:extLst>
                    <a:ext uri="{9D8B030D-6E8A-4147-A177-3AD203B41FA5}">
                      <a16:colId xmlns:a16="http://schemas.microsoft.com/office/drawing/2014/main" xmlns="" val="3270725404"/>
                    </a:ext>
                  </a:extLst>
                </a:gridCol>
                <a:gridCol w="1267327">
                  <a:extLst>
                    <a:ext uri="{9D8B030D-6E8A-4147-A177-3AD203B41FA5}">
                      <a16:colId xmlns:a16="http://schemas.microsoft.com/office/drawing/2014/main" xmlns="" val="3683565691"/>
                    </a:ext>
                  </a:extLst>
                </a:gridCol>
                <a:gridCol w="850231">
                  <a:extLst>
                    <a:ext uri="{9D8B030D-6E8A-4147-A177-3AD203B41FA5}">
                      <a16:colId xmlns:a16="http://schemas.microsoft.com/office/drawing/2014/main" xmlns="" val="3525253308"/>
                    </a:ext>
                  </a:extLst>
                </a:gridCol>
                <a:gridCol w="906585">
                  <a:extLst>
                    <a:ext uri="{9D8B030D-6E8A-4147-A177-3AD203B41FA5}">
                      <a16:colId xmlns:a16="http://schemas.microsoft.com/office/drawing/2014/main" xmlns="" val="2749235395"/>
                    </a:ext>
                  </a:extLst>
                </a:gridCol>
              </a:tblGrid>
              <a:tr h="404646">
                <a:tc rowSpan="2"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2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.    </a:t>
                      </a:r>
                      <a:r>
                        <a:rPr lang="en-US" altLang="ko-KR" sz="20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2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S/ME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es o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Medical records </a:t>
                      </a: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 Rate (%)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e (%)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-CI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 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06282246"/>
                  </a:ext>
                </a:extLst>
              </a:tr>
              <a:tr h="404646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34793040"/>
                  </a:ext>
                </a:extLst>
              </a:tr>
              <a:tr h="301176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ollin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6 [38]  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9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7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1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2.14]</a:t>
                      </a: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98440909"/>
                  </a:ext>
                </a:extLst>
              </a:tr>
              <a:tr h="301176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endParaRPr lang="en-US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usu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 [63]  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10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0; 1.81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41605016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Vincent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2 [64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384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3; 0.05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38537908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endParaRPr lang="en-US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hui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65]   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8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5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09; 3.05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50794679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endParaRPr lang="en-US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Verslui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</a:t>
                      </a:r>
                      <a:r>
                        <a:rPr lang="en-US" sz="15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89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00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7; 0.16]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3540836"/>
                  </a:ext>
                </a:extLst>
              </a:tr>
              <a:tr h="369205">
                <a:tc gridSpan="2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effect model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1; 1.46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4201241"/>
                  </a:ext>
                </a:extLst>
              </a:tr>
              <a:tr h="205705">
                <a:tc gridSpan="3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s 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</a:t>
                      </a: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; 1.71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57745429"/>
                  </a:ext>
                </a:extLst>
              </a:tr>
              <a:tr h="556781"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500" i="1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ko-KR" sz="1500" baseline="30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99.7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1.8360</a:t>
                      </a:r>
                    </a:p>
                    <a:p>
                      <a:pPr marL="0" marR="0" lvl="0" indent="0" algn="l" defTabSz="1320759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lt;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.01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38004142"/>
                  </a:ext>
                </a:extLst>
              </a:tr>
            </a:tbl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22553" y="939375"/>
            <a:ext cx="129181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7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-analysis of prevalence studies with diagnosis by physician determination (A) and review of medical records (B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그룹 13"/>
          <p:cNvGrpSpPr/>
          <p:nvPr/>
        </p:nvGrpSpPr>
        <p:grpSpPr>
          <a:xfrm>
            <a:off x="4149694" y="2093214"/>
            <a:ext cx="5740399" cy="3124394"/>
            <a:chOff x="4031653" y="2038350"/>
            <a:chExt cx="5740399" cy="3124394"/>
          </a:xfrm>
        </p:grpSpPr>
        <p:pic>
          <p:nvPicPr>
            <p:cNvPr id="15" name="그림 1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617919" y="2038350"/>
              <a:ext cx="3279786" cy="2483174"/>
            </a:xfrm>
            <a:prstGeom prst="rect">
              <a:avLst/>
            </a:prstGeom>
          </p:spPr>
        </p:pic>
        <p:grpSp>
          <p:nvGrpSpPr>
            <p:cNvPr id="16" name="그룹 15"/>
            <p:cNvGrpSpPr/>
            <p:nvPr/>
          </p:nvGrpSpPr>
          <p:grpSpPr>
            <a:xfrm>
              <a:off x="4031653" y="4690086"/>
              <a:ext cx="5740399" cy="472658"/>
              <a:chOff x="2010872" y="11871913"/>
              <a:chExt cx="5740399" cy="472658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2010872" y="12026022"/>
                <a:ext cx="5740399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7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           0.04          0.08         0.12         0.16         0.20          0.24 (%)</a:t>
                </a:r>
                <a:endParaRPr lang="ko-KR" altLang="en-US" sz="147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8" name="그림 17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2163272" y="11871913"/>
                <a:ext cx="4698720" cy="199843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xmlns="" val="11698416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0</TotalTime>
  <Words>351</Words>
  <Application>Microsoft Office PowerPoint</Application>
  <PresentationFormat>Custom</PresentationFormat>
  <Paragraphs>25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0016236</cp:lastModifiedBy>
  <cp:revision>21</cp:revision>
  <cp:lastPrinted>2020-01-02T00:55:33Z</cp:lastPrinted>
  <dcterms:created xsi:type="dcterms:W3CDTF">2019-12-30T09:07:39Z</dcterms:created>
  <dcterms:modified xsi:type="dcterms:W3CDTF">2020-02-15T03:26:37Z</dcterms:modified>
</cp:coreProperties>
</file>